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0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749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148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16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888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55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414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123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438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304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41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221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84078-AF81-4E67-90F2-F4C9B9607AA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4EA87-2608-4749-85BC-864BD5B924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135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496669"/>
            <a:ext cx="9144000" cy="5904131"/>
            <a:chOff x="0" y="496669"/>
            <a:chExt cx="9144000" cy="590413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50" r="7373" b="9500"/>
            <a:stretch/>
          </p:blipFill>
          <p:spPr bwMode="auto">
            <a:xfrm>
              <a:off x="0" y="1676400"/>
              <a:ext cx="9144000" cy="46760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685800" y="496669"/>
              <a:ext cx="754380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b="1" dirty="0"/>
                <a:t>S3 Appendix: CDS sequences of </a:t>
              </a:r>
              <a:r>
                <a:rPr lang="en-US" b="1" i="1" dirty="0"/>
                <a:t>SCT</a:t>
              </a:r>
              <a:r>
                <a:rPr lang="en-US" b="1" dirty="0"/>
                <a:t> gene homologs from </a:t>
              </a:r>
              <a:r>
                <a:rPr lang="en-US" b="1" i="1" dirty="0"/>
                <a:t>B. </a:t>
              </a:r>
              <a:r>
                <a:rPr lang="en-US" b="1" i="1" dirty="0" err="1"/>
                <a:t>juncea</a:t>
              </a:r>
              <a:r>
                <a:rPr lang="en-US" b="1" dirty="0"/>
                <a:t> and other </a:t>
              </a:r>
              <a:r>
                <a:rPr lang="en-US" b="1" i="1" dirty="0"/>
                <a:t>Brassica</a:t>
              </a:r>
              <a:r>
                <a:rPr lang="en-US" b="1" dirty="0"/>
                <a:t> species. </a:t>
              </a:r>
              <a:endParaRPr lang="en-US" dirty="0"/>
            </a:p>
          </p:txBody>
        </p:sp>
        <p:sp>
          <p:nvSpPr>
            <p:cNvPr id="3" name="Rectangle 2"/>
            <p:cNvSpPr/>
            <p:nvPr/>
          </p:nvSpPr>
          <p:spPr>
            <a:xfrm>
              <a:off x="238125" y="1828800"/>
              <a:ext cx="8153400" cy="9906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257175" y="3009900"/>
              <a:ext cx="8153400" cy="9906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266700" y="4210050"/>
              <a:ext cx="8153400" cy="9906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266700" y="5410200"/>
              <a:ext cx="8153400" cy="9906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26379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1066800"/>
            <a:ext cx="9144000" cy="4678617"/>
            <a:chOff x="0" y="1066800"/>
            <a:chExt cx="9144000" cy="4678617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910" r="7370" b="7790"/>
            <a:stretch/>
          </p:blipFill>
          <p:spPr bwMode="auto">
            <a:xfrm>
              <a:off x="0" y="1066800"/>
              <a:ext cx="9144000" cy="4678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238125" y="1228725"/>
              <a:ext cx="6924675" cy="9906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2550169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914400"/>
            <a:ext cx="9144000" cy="4726548"/>
            <a:chOff x="0" y="914400"/>
            <a:chExt cx="9144000" cy="4726548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44" r="7553" b="7361"/>
            <a:stretch/>
          </p:blipFill>
          <p:spPr bwMode="auto">
            <a:xfrm>
              <a:off x="0" y="914400"/>
              <a:ext cx="9144000" cy="4726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2514600" y="2562225"/>
              <a:ext cx="2209800" cy="1143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396542" y="2249329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CTamiR37</a:t>
              </a:r>
              <a:endParaRPr lang="en-US" sz="10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3908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0" y="76200"/>
            <a:ext cx="9144000" cy="7115718"/>
            <a:chOff x="0" y="76200"/>
            <a:chExt cx="9144000" cy="7115718"/>
          </a:xfrm>
        </p:grpSpPr>
        <p:grpSp>
          <p:nvGrpSpPr>
            <p:cNvPr id="2" name="Group 1"/>
            <p:cNvGrpSpPr/>
            <p:nvPr/>
          </p:nvGrpSpPr>
          <p:grpSpPr>
            <a:xfrm>
              <a:off x="0" y="76200"/>
              <a:ext cx="9144000" cy="7115718"/>
              <a:chOff x="0" y="76200"/>
              <a:chExt cx="9144000" cy="7115718"/>
            </a:xfrm>
          </p:grpSpPr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500" r="7361" b="7273"/>
              <a:stretch/>
            </p:blipFill>
            <p:spPr bwMode="auto">
              <a:xfrm>
                <a:off x="0" y="76200"/>
                <a:ext cx="9144000" cy="47296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" t="42187" r="7258" b="14732"/>
              <a:stretch/>
            </p:blipFill>
            <p:spPr bwMode="auto">
              <a:xfrm>
                <a:off x="0" y="4800600"/>
                <a:ext cx="9144000" cy="23913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4" name="Rectangle 3"/>
            <p:cNvSpPr/>
            <p:nvPr/>
          </p:nvSpPr>
          <p:spPr>
            <a:xfrm>
              <a:off x="1066800" y="533400"/>
              <a:ext cx="2438400" cy="1143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05050" y="228600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CTamiR36</a:t>
              </a:r>
              <a:endParaRPr lang="en-US" sz="10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38648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685800"/>
            <a:ext cx="8229600" cy="2893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5g09640,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alian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S of  SCT gene from TAIR database 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</a:t>
            </a:r>
            <a:endParaRPr lang="en-US" sz="140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SC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SC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nSCT1 and BnSCT2, are CDS of  SCT gene from EMBL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base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</a:t>
            </a:r>
            <a:endParaRPr lang="en-US" sz="140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jSCT1CDS and BjSCT2CDS SCT gene paralogs isolated from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uncea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morphic regions are shown in black boxes  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ull length gen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was used for the development of antisense constructs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sequences which is shown in red boxes were used for development of RNAi constructs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sequences which are shown in green boxes were used as artificial microRNA targets                                                                     </a:t>
            </a:r>
            <a:endParaRPr lang="en-US" sz="14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84675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110</Words>
  <Application>Microsoft Office PowerPoint</Application>
  <PresentationFormat>On-screen Show (4:3)</PresentationFormat>
  <Paragraphs>16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ajla</dc:creator>
  <cp:lastModifiedBy>Sachin Kajla</cp:lastModifiedBy>
  <cp:revision>11</cp:revision>
  <dcterms:created xsi:type="dcterms:W3CDTF">2017-05-03T10:36:22Z</dcterms:created>
  <dcterms:modified xsi:type="dcterms:W3CDTF">2017-05-08T11:49:40Z</dcterms:modified>
</cp:coreProperties>
</file>